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39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ktangel 2"/>
          <p:cNvSpPr/>
          <p:nvPr/>
        </p:nvSpPr>
        <p:spPr>
          <a:xfrm>
            <a:off x="228600" y="3937337"/>
            <a:ext cx="648482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preparation of the lung tissu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els were prepared as previously described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[13-1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]. For details, see material and methods. 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Bild 1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5" r="68874"/>
          <a:stretch/>
        </p:blipFill>
        <p:spPr bwMode="auto">
          <a:xfrm>
            <a:off x="381000" y="304800"/>
            <a:ext cx="1790700" cy="34671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4</TotalTime>
  <Words>30</Words>
  <Application>Microsoft Office PowerPoint</Application>
  <PresentationFormat>Bildspel på skärme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 1</dc:title>
  <dc:creator>Shawon Gupta</dc:creator>
  <cp:lastModifiedBy>Jonas Klingström</cp:lastModifiedBy>
  <cp:revision>117</cp:revision>
  <cp:lastPrinted>2015-09-07T14:02:09Z</cp:lastPrinted>
  <dcterms:created xsi:type="dcterms:W3CDTF">2012-05-16T12:12:27Z</dcterms:created>
  <dcterms:modified xsi:type="dcterms:W3CDTF">2016-02-12T12:16:20Z</dcterms:modified>
</cp:coreProperties>
</file>